
<file path=[Content_Types].xml><?xml version="1.0" encoding="utf-8"?>
<Types xmlns="http://schemas.openxmlformats.org/package/2006/content-types">
  <Default Extension="emf" ContentType="image/x-emf"/>
  <Override PartName="/docProps/core.xml" ContentType="application/vnd.openxmlformats-package.core-properties+xml"/>
  <Override PartName="/ppt/slideLayouts/slideLayout6.xml" ContentType="application/vnd.openxmlformats-officedocument.presentationml.slideLayout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906000" cy="6858000" type="A4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a="http://schemas.openxmlformats.org/drawingml/2006/main" xmlns:r="http://schemas.openxmlformats.org/officeDocument/2006/relationships" xmlns:p="http://schemas.openxmlformats.org/presentationml/2006/main" xmlns:p15="http://schemas.microsoft.com/office/powerpoint/2012/main" xmlns:mv="urn:schemas-microsoft-com:mac:vml" xmlns:mc="http://schemas.openxmlformats.org/markup-compatibility/2006">
        <p15:guide id="1" orient="horz" pos="3249" userDrawn="1">
          <p15:clr>
            <a:srgbClr val="A4A3A4"/>
          </p15:clr>
        </p15:guide>
        <p15:guide id="2" pos="50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20"/>
    </p:ext>
    <p:ext uri="{FD5EFAAD-0ECE-453E-9831-46B23BE46B34}">
      <p15:chartTrackingRefBased xmlns="" xmlns:a="http://schemas.openxmlformats.org/drawingml/2006/main" xmlns:r="http://schemas.openxmlformats.org/officeDocument/2006/relationships" xmlns:p="http://schemas.openxmlformats.org/presentationml/2006/main" xmlns:p15="http://schemas.microsoft.com/office/powerpoint/2012/main" xmlns:mv="urn:schemas-microsoft-com:mac:vml" xmlns:mc="http://schemas.openxmlformats.org/markup-compatibility/2006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14"/>
    <p:restoredTop sz="94687"/>
  </p:normalViewPr>
  <p:slideViewPr>
    <p:cSldViewPr snapToGrid="0" snapToObjects="1" showGuides="1">
      <p:cViewPr varScale="1">
        <p:scale>
          <a:sx n="69" d="100"/>
          <a:sy n="69" d="100"/>
        </p:scale>
        <p:origin x="-1208" y="-96"/>
      </p:cViewPr>
      <p:guideLst>
        <p:guide orient="horz" pos="3249"/>
        <p:guide pos="504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C2E3DCB-6D89-A643-97DF-C1B76EC6F224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96679F-317A-3849-A324-62788B601B97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9912746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96679F-317A-3849-A324-62788B601B97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42481811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997F6-29C7-7143-9349-EF71664B81AA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FE3FD1-B7D3-DD4B-9BE1-5EB5D3EEA43E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997F6-29C7-7143-9349-EF71664B81AA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FE3FD1-B7D3-DD4B-9BE1-5EB5D3EEA43E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997F6-29C7-7143-9349-EF71664B81AA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FE3FD1-B7D3-DD4B-9BE1-5EB5D3EEA43E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997F6-29C7-7143-9349-EF71664B81AA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FE3FD1-B7D3-DD4B-9BE1-5EB5D3EEA43E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997F6-29C7-7143-9349-EF71664B81AA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FE3FD1-B7D3-DD4B-9BE1-5EB5D3EEA43E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997F6-29C7-7143-9349-EF71664B81AA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FE3FD1-B7D3-DD4B-9BE1-5EB5D3EEA43E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997F6-29C7-7143-9349-EF71664B81AA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FE3FD1-B7D3-DD4B-9BE1-5EB5D3EEA43E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997F6-29C7-7143-9349-EF71664B81AA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FE3FD1-B7D3-DD4B-9BE1-5EB5D3EEA43E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997F6-29C7-7143-9349-EF71664B81AA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FE3FD1-B7D3-DD4B-9BE1-5EB5D3EEA43E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997F6-29C7-7143-9349-EF71664B81AA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FE3FD1-B7D3-DD4B-9BE1-5EB5D3EEA43E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997F6-29C7-7143-9349-EF71664B81AA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FE3FD1-B7D3-DD4B-9BE1-5EB5D3EEA43E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4997F6-29C7-7143-9349-EF71664B81AA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FE3FD1-B7D3-DD4B-9BE1-5EB5D3EEA43E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4" name="Grouper 173"/>
          <p:cNvGrpSpPr/>
          <p:nvPr/>
        </p:nvGrpSpPr>
        <p:grpSpPr>
          <a:xfrm>
            <a:off x="1030380" y="549128"/>
            <a:ext cx="7756705" cy="5575031"/>
            <a:chOff x="1030380" y="549128"/>
            <a:chExt cx="7756705" cy="5575031"/>
          </a:xfrm>
        </p:grpSpPr>
        <p:sp>
          <p:nvSpPr>
            <p:cNvPr id="172" name="TextBox 117">
              <a:extLst>
                <a:ext uri="{FF2B5EF4-FFF2-40B4-BE49-F238E27FC236}">
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DCB9911-4016-444C-8BB5-F245EF031799}"/>
                </a:ext>
              </a:extLst>
            </p:cNvPr>
            <p:cNvSpPr txBox="1"/>
            <p:nvPr/>
          </p:nvSpPr>
          <p:spPr>
            <a:xfrm>
              <a:off x="1030380" y="5847160"/>
              <a:ext cx="6935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7 Fig</a:t>
              </a:r>
            </a:p>
          </p:txBody>
        </p:sp>
        <p:grpSp>
          <p:nvGrpSpPr>
            <p:cNvPr id="5" name="Groupe 4">
              <a:extLst>
                <a:ext uri="{FF2B5EF4-FFF2-40B4-BE49-F238E27FC236}">
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9ACE02C-5513-864E-AE6D-470630328265}"/>
                </a:ext>
              </a:extLst>
            </p:cNvPr>
            <p:cNvGrpSpPr/>
            <p:nvPr/>
          </p:nvGrpSpPr>
          <p:grpSpPr>
            <a:xfrm>
              <a:off x="1153429" y="549128"/>
              <a:ext cx="7633656" cy="5159595"/>
              <a:chOff x="1153429" y="549128"/>
              <a:chExt cx="7633656" cy="5159595"/>
            </a:xfrm>
          </p:grpSpPr>
          <p:grpSp>
            <p:nvGrpSpPr>
              <p:cNvPr id="12" name="Groupe 11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428EBED-3F0E-CC42-86F8-1AEC1EF8C78B}"/>
                  </a:ext>
                </a:extLst>
              </p:cNvPr>
              <p:cNvGrpSpPr/>
              <p:nvPr/>
            </p:nvGrpSpPr>
            <p:grpSpPr>
              <a:xfrm>
                <a:off x="1153429" y="549128"/>
                <a:ext cx="7633656" cy="1701599"/>
                <a:chOff x="1153429" y="549128"/>
                <a:chExt cx="7633656" cy="1701599"/>
              </a:xfrm>
            </p:grpSpPr>
            <p:grpSp>
              <p:nvGrpSpPr>
                <p:cNvPr id="81" name="Grouper 43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130F447-6DD7-3B4F-AD1F-CCFBFA07EB79}"/>
                    </a:ext>
                  </a:extLst>
                </p:cNvPr>
                <p:cNvGrpSpPr/>
                <p:nvPr/>
              </p:nvGrpSpPr>
              <p:grpSpPr>
                <a:xfrm>
                  <a:off x="1535394" y="678611"/>
                  <a:ext cx="718214" cy="551256"/>
                  <a:chOff x="1365121" y="2167514"/>
                  <a:chExt cx="750477" cy="590749"/>
                </a:xfrm>
              </p:grpSpPr>
              <p:sp>
                <p:nvSpPr>
                  <p:cNvPr id="151" name="TextBox 10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6A02A7A-1742-5A48-89C8-82B021AEEA5D}"/>
                      </a:ext>
                    </a:extLst>
                  </p:cNvPr>
                  <p:cNvSpPr txBox="1"/>
                  <p:nvPr/>
                </p:nvSpPr>
                <p:spPr>
                  <a:xfrm>
                    <a:off x="1365121" y="2362471"/>
                    <a:ext cx="750477" cy="39579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04240</a:t>
                    </a:r>
                  </a:p>
                </p:txBody>
              </p:sp>
              <p:sp>
                <p:nvSpPr>
                  <p:cNvPr id="152" name="TextBox 10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59F759A-FC62-0C49-ADA5-B987CBA36EAF}"/>
                      </a:ext>
                    </a:extLst>
                  </p:cNvPr>
                  <p:cNvSpPr txBox="1"/>
                  <p:nvPr/>
                </p:nvSpPr>
                <p:spPr>
                  <a:xfrm>
                    <a:off x="1412515" y="2167514"/>
                    <a:ext cx="622130" cy="28035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dirty="0" err="1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onB</a:t>
                    </a:r>
                    <a:endParaRPr lang="en-US" sz="1100" b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82" name="Grouper 44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DE17905-2C0F-8441-A246-E05B16AA22B5}"/>
                    </a:ext>
                  </a:extLst>
                </p:cNvPr>
                <p:cNvGrpSpPr/>
                <p:nvPr/>
              </p:nvGrpSpPr>
              <p:grpSpPr>
                <a:xfrm>
                  <a:off x="2039677" y="570383"/>
                  <a:ext cx="621928" cy="573949"/>
                  <a:chOff x="1750804" y="1658391"/>
                  <a:chExt cx="649866" cy="615067"/>
                </a:xfrm>
              </p:grpSpPr>
              <p:sp>
                <p:nvSpPr>
                  <p:cNvPr id="149" name="TextBox 108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598FF38-0275-3E49-B066-227D94573353}"/>
                      </a:ext>
                    </a:extLst>
                  </p:cNvPr>
                  <p:cNvSpPr txBox="1"/>
                  <p:nvPr/>
                </p:nvSpPr>
                <p:spPr>
                  <a:xfrm>
                    <a:off x="1750804" y="1658391"/>
                    <a:ext cx="637684" cy="28035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dirty="0" err="1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bD</a:t>
                    </a:r>
                    <a:endParaRPr lang="en-US" sz="1100" b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0" name="TextBox 10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5362126-8D30-0045-9B33-B5DF2E671CEF}"/>
                      </a:ext>
                    </a:extLst>
                  </p:cNvPr>
                  <p:cNvSpPr txBox="1"/>
                  <p:nvPr/>
                </p:nvSpPr>
                <p:spPr>
                  <a:xfrm>
                    <a:off x="1750804" y="1877667"/>
                    <a:ext cx="649866" cy="39579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04245</a:t>
                    </a:r>
                  </a:p>
                </p:txBody>
              </p:sp>
            </p:grpSp>
            <p:grpSp>
              <p:nvGrpSpPr>
                <p:cNvPr id="83" name="Grouper 4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0479958-A842-1A4F-B1CE-06476D310E90}"/>
                    </a:ext>
                  </a:extLst>
                </p:cNvPr>
                <p:cNvGrpSpPr/>
                <p:nvPr/>
              </p:nvGrpSpPr>
              <p:grpSpPr>
                <a:xfrm>
                  <a:off x="2469678" y="679001"/>
                  <a:ext cx="648386" cy="550478"/>
                  <a:chOff x="2119896" y="2125180"/>
                  <a:chExt cx="677512" cy="589915"/>
                </a:xfrm>
              </p:grpSpPr>
              <p:sp>
                <p:nvSpPr>
                  <p:cNvPr id="147" name="TextBox 11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7F693FA-9159-AB4F-A4D1-B9C5BAC1F792}"/>
                      </a:ext>
                    </a:extLst>
                  </p:cNvPr>
                  <p:cNvSpPr txBox="1"/>
                  <p:nvPr/>
                </p:nvSpPr>
                <p:spPr>
                  <a:xfrm>
                    <a:off x="2119896" y="2125180"/>
                    <a:ext cx="642569" cy="28035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dirty="0" err="1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bD</a:t>
                    </a:r>
                    <a:endParaRPr lang="en-US" sz="1100" b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8" name="TextBox 10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AA07582-BD5A-7044-AA17-892C716728AB}"/>
                      </a:ext>
                    </a:extLst>
                  </p:cNvPr>
                  <p:cNvSpPr txBox="1"/>
                  <p:nvPr/>
                </p:nvSpPr>
                <p:spPr>
                  <a:xfrm>
                    <a:off x="2133115" y="2319304"/>
                    <a:ext cx="664293" cy="39579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04250</a:t>
                    </a:r>
                  </a:p>
                </p:txBody>
              </p:sp>
            </p:grpSp>
            <p:grpSp>
              <p:nvGrpSpPr>
                <p:cNvPr id="84" name="Grouper 46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312A4B1-7AD6-264D-8F22-7ACAF42A4EEC}"/>
                    </a:ext>
                  </a:extLst>
                </p:cNvPr>
                <p:cNvGrpSpPr/>
                <p:nvPr/>
              </p:nvGrpSpPr>
              <p:grpSpPr>
                <a:xfrm>
                  <a:off x="3057063" y="657325"/>
                  <a:ext cx="633571" cy="581951"/>
                  <a:chOff x="2502069" y="1472096"/>
                  <a:chExt cx="662033" cy="623643"/>
                </a:xfrm>
              </p:grpSpPr>
              <p:sp>
                <p:nvSpPr>
                  <p:cNvPr id="145" name="TextBox 11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701087C-B5CD-B840-8727-9D5B261C41BE}"/>
                      </a:ext>
                    </a:extLst>
                  </p:cNvPr>
                  <p:cNvSpPr txBox="1"/>
                  <p:nvPr/>
                </p:nvSpPr>
                <p:spPr>
                  <a:xfrm>
                    <a:off x="2516172" y="1472096"/>
                    <a:ext cx="628137" cy="28035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dirty="0" err="1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bB</a:t>
                    </a:r>
                    <a:endParaRPr lang="en-US" sz="1100" b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6" name="TextBox 10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9D06F97-4CD9-6740-8D83-0679942E9046}"/>
                      </a:ext>
                    </a:extLst>
                  </p:cNvPr>
                  <p:cNvSpPr txBox="1"/>
                  <p:nvPr/>
                </p:nvSpPr>
                <p:spPr>
                  <a:xfrm>
                    <a:off x="2502069" y="1699948"/>
                    <a:ext cx="662033" cy="39579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04255</a:t>
                    </a:r>
                  </a:p>
                </p:txBody>
              </p:sp>
            </p:grpSp>
            <p:grpSp>
              <p:nvGrpSpPr>
                <p:cNvPr id="85" name="Groupe 110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0F05E43-3B57-E44A-88DD-59C2EEFCAF6C}"/>
                    </a:ext>
                  </a:extLst>
                </p:cNvPr>
                <p:cNvGrpSpPr/>
                <p:nvPr/>
              </p:nvGrpSpPr>
              <p:grpSpPr>
                <a:xfrm>
                  <a:off x="3747469" y="1453246"/>
                  <a:ext cx="663247" cy="568974"/>
                  <a:chOff x="4072524" y="3881433"/>
                  <a:chExt cx="693041" cy="609736"/>
                </a:xfrm>
              </p:grpSpPr>
              <p:sp>
                <p:nvSpPr>
                  <p:cNvPr id="143" name="TextBox 11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FF61A08-8BFB-0D45-AC9A-6C16144B91C0}"/>
                      </a:ext>
                    </a:extLst>
                  </p:cNvPr>
                  <p:cNvSpPr txBox="1"/>
                  <p:nvPr/>
                </p:nvSpPr>
                <p:spPr>
                  <a:xfrm>
                    <a:off x="4095252" y="3881433"/>
                    <a:ext cx="571710" cy="28035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ypo</a:t>
                    </a:r>
                  </a:p>
                </p:txBody>
              </p:sp>
              <p:sp>
                <p:nvSpPr>
                  <p:cNvPr id="144" name="TextBox 10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BA21E6E-65F8-DA41-99EF-51245AC84B1E}"/>
                      </a:ext>
                    </a:extLst>
                  </p:cNvPr>
                  <p:cNvSpPr txBox="1"/>
                  <p:nvPr/>
                </p:nvSpPr>
                <p:spPr>
                  <a:xfrm>
                    <a:off x="4072524" y="4095378"/>
                    <a:ext cx="693041" cy="39579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04260</a:t>
                    </a:r>
                  </a:p>
                </p:txBody>
              </p:sp>
            </p:grpSp>
            <p:grpSp>
              <p:nvGrpSpPr>
                <p:cNvPr id="86" name="Groupe 109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5FECD72-085A-3549-9BFB-8A7298E8D58B}"/>
                    </a:ext>
                  </a:extLst>
                </p:cNvPr>
                <p:cNvGrpSpPr/>
                <p:nvPr/>
              </p:nvGrpSpPr>
              <p:grpSpPr>
                <a:xfrm>
                  <a:off x="4277116" y="1453246"/>
                  <a:ext cx="653013" cy="568980"/>
                  <a:chOff x="4625964" y="3881433"/>
                  <a:chExt cx="682347" cy="609742"/>
                </a:xfrm>
              </p:grpSpPr>
              <p:sp>
                <p:nvSpPr>
                  <p:cNvPr id="141" name="TextBox 11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906B4FF-810E-254D-AF3B-1C9B7C552144}"/>
                      </a:ext>
                    </a:extLst>
                  </p:cNvPr>
                  <p:cNvSpPr txBox="1"/>
                  <p:nvPr/>
                </p:nvSpPr>
                <p:spPr>
                  <a:xfrm>
                    <a:off x="4630468" y="3881433"/>
                    <a:ext cx="661248" cy="28035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ypo</a:t>
                    </a:r>
                  </a:p>
                </p:txBody>
              </p:sp>
              <p:sp>
                <p:nvSpPr>
                  <p:cNvPr id="142" name="TextBox 10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BB6B4B3-FA64-4743-A10F-BEE8AB1BAC9F}"/>
                      </a:ext>
                    </a:extLst>
                  </p:cNvPr>
                  <p:cNvSpPr txBox="1"/>
                  <p:nvPr/>
                </p:nvSpPr>
                <p:spPr>
                  <a:xfrm>
                    <a:off x="4625964" y="4095384"/>
                    <a:ext cx="682347" cy="39579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04265</a:t>
                    </a:r>
                  </a:p>
                </p:txBody>
              </p:sp>
            </p:grpSp>
            <p:grpSp>
              <p:nvGrpSpPr>
                <p:cNvPr id="87" name="Grouper 248"/>
                <p:cNvGrpSpPr/>
                <p:nvPr/>
              </p:nvGrpSpPr>
              <p:grpSpPr>
                <a:xfrm>
                  <a:off x="3520679" y="549128"/>
                  <a:ext cx="4891993" cy="817215"/>
                  <a:chOff x="3835548" y="7058291"/>
                  <a:chExt cx="5111746" cy="875757"/>
                </a:xfrm>
              </p:grpSpPr>
              <p:sp>
                <p:nvSpPr>
                  <p:cNvPr id="139" name="TextBox 11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7154877-6091-E34B-9810-DCA0C64AC729}"/>
                      </a:ext>
                    </a:extLst>
                  </p:cNvPr>
                  <p:cNvSpPr txBox="1"/>
                  <p:nvPr/>
                </p:nvSpPr>
                <p:spPr>
                  <a:xfrm>
                    <a:off x="5441150" y="7058291"/>
                    <a:ext cx="972084" cy="4617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dirty="0" err="1" smtClean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onB-dpt</a:t>
                    </a:r>
                    <a:endParaRPr lang="en-US" sz="11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ctr"/>
                    <a:r>
                      <a:rPr lang="en-US" sz="1100" b="1" dirty="0" smtClean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eceptor</a:t>
                    </a:r>
                    <a:endParaRPr lang="en-US" sz="1100" b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0" name="TextBox 10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6BB44B6-5F5D-1A44-8B16-6103917E3936}"/>
                      </a:ext>
                    </a:extLst>
                  </p:cNvPr>
                  <p:cNvSpPr txBox="1"/>
                  <p:nvPr/>
                </p:nvSpPr>
                <p:spPr>
                  <a:xfrm>
                    <a:off x="5428642" y="7497257"/>
                    <a:ext cx="997101" cy="24736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_04270</a:t>
                    </a:r>
                  </a:p>
                </p:txBody>
              </p:sp>
              <p:sp>
                <p:nvSpPr>
                  <p:cNvPr id="162" name="TextBox 10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3B1D1CD-FE99-1C45-8F66-E6422C50558A}"/>
                      </a:ext>
                    </a:extLst>
                  </p:cNvPr>
                  <p:cNvSpPr txBox="1"/>
                  <p:nvPr/>
                </p:nvSpPr>
                <p:spPr>
                  <a:xfrm>
                    <a:off x="3835548" y="7686680"/>
                    <a:ext cx="405190" cy="24736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i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62</a:t>
                    </a:r>
                  </a:p>
                </p:txBody>
              </p:sp>
              <p:sp>
                <p:nvSpPr>
                  <p:cNvPr id="167" name="TextBox 10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020B208-FB26-B84C-AC48-962B61B6998A}"/>
                      </a:ext>
                    </a:extLst>
                  </p:cNvPr>
                  <p:cNvSpPr txBox="1"/>
                  <p:nvPr/>
                </p:nvSpPr>
                <p:spPr>
                  <a:xfrm>
                    <a:off x="4484854" y="7686678"/>
                    <a:ext cx="405190" cy="24736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i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24</a:t>
                    </a:r>
                  </a:p>
                </p:txBody>
              </p:sp>
              <p:sp>
                <p:nvSpPr>
                  <p:cNvPr id="168" name="TextBox 10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59DBB42-3AD7-2F46-9497-5D6973E3AC66}"/>
                      </a:ext>
                    </a:extLst>
                  </p:cNvPr>
                  <p:cNvSpPr txBox="1"/>
                  <p:nvPr/>
                </p:nvSpPr>
                <p:spPr>
                  <a:xfrm>
                    <a:off x="4935102" y="7686678"/>
                    <a:ext cx="405190" cy="24736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i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22</a:t>
                    </a:r>
                  </a:p>
                </p:txBody>
              </p:sp>
              <p:sp>
                <p:nvSpPr>
                  <p:cNvPr id="169" name="TextBox 10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12908B1-1858-614D-B9E4-24346A0EA89E}"/>
                      </a:ext>
                    </a:extLst>
                  </p:cNvPr>
                  <p:cNvSpPr txBox="1"/>
                  <p:nvPr/>
                </p:nvSpPr>
                <p:spPr>
                  <a:xfrm>
                    <a:off x="7016255" y="7686678"/>
                    <a:ext cx="405190" cy="24736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i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4</a:t>
                    </a:r>
                  </a:p>
                </p:txBody>
              </p:sp>
              <p:sp>
                <p:nvSpPr>
                  <p:cNvPr id="170" name="TextBox 10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EEBE911-76FD-144C-B4DB-D8EDC6655564}"/>
                      </a:ext>
                    </a:extLst>
                  </p:cNvPr>
                  <p:cNvSpPr txBox="1"/>
                  <p:nvPr/>
                </p:nvSpPr>
                <p:spPr>
                  <a:xfrm>
                    <a:off x="7917679" y="7686678"/>
                    <a:ext cx="405190" cy="24736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i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7</a:t>
                    </a:r>
                  </a:p>
                </p:txBody>
              </p:sp>
              <p:sp>
                <p:nvSpPr>
                  <p:cNvPr id="171" name="TextBox 10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E6F120E-2C23-514A-9F3E-85E45075F0C9}"/>
                      </a:ext>
                    </a:extLst>
                  </p:cNvPr>
                  <p:cNvSpPr txBox="1"/>
                  <p:nvPr/>
                </p:nvSpPr>
                <p:spPr>
                  <a:xfrm>
                    <a:off x="8542104" y="7686678"/>
                    <a:ext cx="405190" cy="24736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i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77</a:t>
                    </a:r>
                  </a:p>
                </p:txBody>
              </p:sp>
            </p:grpSp>
            <p:grpSp>
              <p:nvGrpSpPr>
                <p:cNvPr id="88" name="Grouper 249"/>
                <p:cNvGrpSpPr/>
                <p:nvPr/>
              </p:nvGrpSpPr>
              <p:grpSpPr>
                <a:xfrm>
                  <a:off x="6172221" y="642516"/>
                  <a:ext cx="693153" cy="547005"/>
                  <a:chOff x="6606199" y="7158431"/>
                  <a:chExt cx="724290" cy="586195"/>
                </a:xfrm>
              </p:grpSpPr>
              <p:sp>
                <p:nvSpPr>
                  <p:cNvPr id="137" name="TextBox 11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22E72AC-0725-A847-ABA0-B9ACAD222F62}"/>
                      </a:ext>
                    </a:extLst>
                  </p:cNvPr>
                  <p:cNvSpPr txBox="1"/>
                  <p:nvPr/>
                </p:nvSpPr>
                <p:spPr>
                  <a:xfrm>
                    <a:off x="6646225" y="7158431"/>
                    <a:ext cx="631940" cy="28035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ypo</a:t>
                    </a:r>
                  </a:p>
                </p:txBody>
              </p:sp>
              <p:sp>
                <p:nvSpPr>
                  <p:cNvPr id="138" name="TextBox 10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7138A9A-B379-8744-8834-64E528EA6284}"/>
                      </a:ext>
                    </a:extLst>
                  </p:cNvPr>
                  <p:cNvSpPr txBox="1"/>
                  <p:nvPr/>
                </p:nvSpPr>
                <p:spPr>
                  <a:xfrm>
                    <a:off x="6606199" y="7348835"/>
                    <a:ext cx="724290" cy="39579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04275</a:t>
                    </a:r>
                  </a:p>
                </p:txBody>
              </p:sp>
            </p:grpSp>
            <p:grpSp>
              <p:nvGrpSpPr>
                <p:cNvPr id="89" name="Grouper 250"/>
                <p:cNvGrpSpPr/>
                <p:nvPr/>
              </p:nvGrpSpPr>
              <p:grpSpPr>
                <a:xfrm>
                  <a:off x="6829256" y="642516"/>
                  <a:ext cx="722518" cy="547005"/>
                  <a:chOff x="7292749" y="7158431"/>
                  <a:chExt cx="754974" cy="586195"/>
                </a:xfrm>
              </p:grpSpPr>
              <p:sp>
                <p:nvSpPr>
                  <p:cNvPr id="135" name="TextBox 12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FA6A235-7AA0-EE43-A8D8-38D37D5C43BC}"/>
                      </a:ext>
                    </a:extLst>
                  </p:cNvPr>
                  <p:cNvSpPr txBox="1"/>
                  <p:nvPr/>
                </p:nvSpPr>
                <p:spPr>
                  <a:xfrm>
                    <a:off x="7337842" y="7158431"/>
                    <a:ext cx="664786" cy="28035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pL48</a:t>
                    </a:r>
                  </a:p>
                </p:txBody>
              </p:sp>
              <p:sp>
                <p:nvSpPr>
                  <p:cNvPr id="136" name="TextBox 10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1713CE9-3EE1-0749-9E2E-82CBBBDFFA2A}"/>
                      </a:ext>
                    </a:extLst>
                  </p:cNvPr>
                  <p:cNvSpPr txBox="1"/>
                  <p:nvPr/>
                </p:nvSpPr>
                <p:spPr>
                  <a:xfrm>
                    <a:off x="7292749" y="7348835"/>
                    <a:ext cx="754974" cy="39579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04280</a:t>
                    </a:r>
                  </a:p>
                </p:txBody>
              </p:sp>
            </p:grpSp>
            <p:grpSp>
              <p:nvGrpSpPr>
                <p:cNvPr id="90" name="Groupe 111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C461D0F-E86F-0A48-AE39-4C237DE39334}"/>
                    </a:ext>
                  </a:extLst>
                </p:cNvPr>
                <p:cNvGrpSpPr/>
                <p:nvPr/>
              </p:nvGrpSpPr>
              <p:grpSpPr>
                <a:xfrm>
                  <a:off x="7514560" y="642531"/>
                  <a:ext cx="704227" cy="547002"/>
                  <a:chOff x="8008838" y="3012650"/>
                  <a:chExt cx="735862" cy="586192"/>
                </a:xfrm>
              </p:grpSpPr>
              <p:sp>
                <p:nvSpPr>
                  <p:cNvPr id="133" name="TextBox 11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AA1743C-8C4E-1844-8CAE-05EAF33CFBCD}"/>
                      </a:ext>
                    </a:extLst>
                  </p:cNvPr>
                  <p:cNvSpPr txBox="1"/>
                  <p:nvPr/>
                </p:nvSpPr>
                <p:spPr>
                  <a:xfrm>
                    <a:off x="8046145" y="3012650"/>
                    <a:ext cx="661247" cy="28035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ypo</a:t>
                    </a:r>
                  </a:p>
                </p:txBody>
              </p:sp>
              <p:sp>
                <p:nvSpPr>
                  <p:cNvPr id="134" name="TextBox 10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20770A2-B95A-AF4A-A8BE-DD8D44E00805}"/>
                      </a:ext>
                    </a:extLst>
                  </p:cNvPr>
                  <p:cNvSpPr txBox="1"/>
                  <p:nvPr/>
                </p:nvSpPr>
                <p:spPr>
                  <a:xfrm>
                    <a:off x="8008838" y="3203051"/>
                    <a:ext cx="735862" cy="39579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04285</a:t>
                    </a:r>
                  </a:p>
                </p:txBody>
              </p:sp>
            </p:grpSp>
            <p:grpSp>
              <p:nvGrpSpPr>
                <p:cNvPr id="91" name="Groupe 112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E0C495C-B4ED-5844-9502-CC6B56464C4C}"/>
                    </a:ext>
                  </a:extLst>
                </p:cNvPr>
                <p:cNvGrpSpPr/>
                <p:nvPr/>
              </p:nvGrpSpPr>
              <p:grpSpPr>
                <a:xfrm>
                  <a:off x="8154189" y="642531"/>
                  <a:ext cx="632896" cy="547002"/>
                  <a:chOff x="8677200" y="3012650"/>
                  <a:chExt cx="661326" cy="586192"/>
                </a:xfrm>
              </p:grpSpPr>
              <p:sp>
                <p:nvSpPr>
                  <p:cNvPr id="131" name="TextBox 10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6061151-6228-804A-8028-A079B742CEDE}"/>
                      </a:ext>
                    </a:extLst>
                  </p:cNvPr>
                  <p:cNvSpPr txBox="1"/>
                  <p:nvPr/>
                </p:nvSpPr>
                <p:spPr>
                  <a:xfrm>
                    <a:off x="8677200" y="3203051"/>
                    <a:ext cx="661326" cy="39579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04290</a:t>
                    </a:r>
                  </a:p>
                </p:txBody>
              </p:sp>
              <p:sp>
                <p:nvSpPr>
                  <p:cNvPr id="132" name="TextBox 11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69BA0FD-4A10-AF46-BE04-1CC302660BC0}"/>
                      </a:ext>
                    </a:extLst>
                  </p:cNvPr>
                  <p:cNvSpPr txBox="1"/>
                  <p:nvPr/>
                </p:nvSpPr>
                <p:spPr>
                  <a:xfrm>
                    <a:off x="8677240" y="3012650"/>
                    <a:ext cx="661247" cy="28035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ypo</a:t>
                    </a:r>
                  </a:p>
                </p:txBody>
              </p:sp>
            </p:grpSp>
            <p:sp>
              <p:nvSpPr>
                <p:cNvPr id="92" name="TextBox 104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3D03D65-DBB5-1848-BD69-82B661B1EE53}"/>
                    </a:ext>
                  </a:extLst>
                </p:cNvPr>
                <p:cNvSpPr txBox="1"/>
                <p:nvPr/>
              </p:nvSpPr>
              <p:spPr>
                <a:xfrm>
                  <a:off x="3637302" y="748470"/>
                  <a:ext cx="773411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LEPIMA</a:t>
                  </a:r>
                </a:p>
                <a:p>
                  <a:pPr algn="ctr"/>
                  <a:r>
                    <a:rPr lang="en-US" sz="900" b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_CI0931</a:t>
                  </a:r>
                </a:p>
              </p:txBody>
            </p:sp>
            <p:grpSp>
              <p:nvGrpSpPr>
                <p:cNvPr id="93" name="Grouper 56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B959E0E-89BB-3145-B2E1-156034C97902}"/>
                    </a:ext>
                  </a:extLst>
                </p:cNvPr>
                <p:cNvGrpSpPr/>
                <p:nvPr/>
              </p:nvGrpSpPr>
              <p:grpSpPr>
                <a:xfrm>
                  <a:off x="1153429" y="1167116"/>
                  <a:ext cx="7531200" cy="300640"/>
                  <a:chOff x="1224059" y="2640522"/>
                  <a:chExt cx="5295298" cy="322178"/>
                </a:xfrm>
              </p:grpSpPr>
              <p:cxnSp>
                <p:nvCxnSpPr>
                  <p:cNvPr id="118" name="Straight Connector 1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D86D8FD-6128-4A4C-98A9-2001D0745B11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1224059" y="2831622"/>
                    <a:ext cx="5295298" cy="2876"/>
                  </a:xfrm>
                  <a:prstGeom prst="line">
                    <a:avLst/>
                  </a:prstGeom>
                  <a:ln w="19050" cap="flat" cmpd="sng" algn="ctr">
                    <a:solidFill>
                      <a:schemeClr val="dk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9" name="Down Arrow 126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C9F4069-A27A-C548-8DCE-BF48E551F38B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5400000">
                    <a:off x="2615527" y="2636813"/>
                    <a:ext cx="259273" cy="392483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0" name="Down Arrow 12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4C1B724-7A86-864F-81A2-B6E10BAABCE6}"/>
                      </a:ext>
                    </a:extLst>
                  </p:cNvPr>
                  <p:cNvSpPr>
                    <a:spLocks/>
                  </p:cNvSpPr>
                  <p:nvPr/>
                </p:nvSpPr>
                <p:spPr>
                  <a:xfrm rot="5400000">
                    <a:off x="2216266" y="2689056"/>
                    <a:ext cx="259273" cy="287998"/>
                  </a:xfrm>
                  <a:prstGeom prst="downArrow">
                    <a:avLst/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1" name="Down Arrow 128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A646EF7-05F8-144D-90BB-F4E48F7A2568}"/>
                      </a:ext>
                    </a:extLst>
                  </p:cNvPr>
                  <p:cNvSpPr>
                    <a:spLocks/>
                  </p:cNvSpPr>
                  <p:nvPr/>
                </p:nvSpPr>
                <p:spPr>
                  <a:xfrm rot="5400000">
                    <a:off x="1921529" y="2689056"/>
                    <a:ext cx="259273" cy="287998"/>
                  </a:xfrm>
                  <a:prstGeom prst="downArrow">
                    <a:avLst/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600" b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2" name="Down Arrow 129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7470DBB-C0BA-E64A-ACC2-9D5BBAD212A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5400000">
                    <a:off x="1610894" y="2671769"/>
                    <a:ext cx="259273" cy="322573"/>
                  </a:xfrm>
                  <a:prstGeom prst="downArrow">
                    <a:avLst/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600" b="1" i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3" name="Down Arrow 130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1265809-C231-854E-B1DE-2AA2EECF8F62}"/>
                      </a:ext>
                    </a:extLst>
                  </p:cNvPr>
                  <p:cNvSpPr>
                    <a:spLocks/>
                  </p:cNvSpPr>
                  <p:nvPr/>
                </p:nvSpPr>
                <p:spPr>
                  <a:xfrm rot="5400000">
                    <a:off x="4803219" y="2653061"/>
                    <a:ext cx="259274" cy="359997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4" name="Down Arrow 13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34DA9AB-A13B-224D-9E70-625033B7F5A6}"/>
                      </a:ext>
                    </a:extLst>
                  </p:cNvPr>
                  <p:cNvSpPr>
                    <a:spLocks/>
                  </p:cNvSpPr>
                  <p:nvPr/>
                </p:nvSpPr>
                <p:spPr>
                  <a:xfrm rot="5400000">
                    <a:off x="3464818" y="2761064"/>
                    <a:ext cx="259274" cy="143998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5" name="Down Arrow 13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4C0202E-9EE9-7F46-8BDE-F2D898CFC0E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5400000">
                    <a:off x="3102225" y="2696214"/>
                    <a:ext cx="259273" cy="273683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6" name="Down Arrow 13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462FE7A-CBC8-B840-84F7-EA9FF9E9F7A1}"/>
                      </a:ext>
                    </a:extLst>
                  </p:cNvPr>
                  <p:cNvSpPr>
                    <a:spLocks/>
                  </p:cNvSpPr>
                  <p:nvPr/>
                </p:nvSpPr>
                <p:spPr>
                  <a:xfrm rot="5400000">
                    <a:off x="4173821" y="2382329"/>
                    <a:ext cx="259274" cy="901465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7" name="Down Arrow 13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C445806-6D16-C54A-B65C-BC1DA2F6FFBA}"/>
                      </a:ext>
                    </a:extLst>
                  </p:cNvPr>
                  <p:cNvSpPr>
                    <a:spLocks/>
                  </p:cNvSpPr>
                  <p:nvPr/>
                </p:nvSpPr>
                <p:spPr>
                  <a:xfrm rot="5400000">
                    <a:off x="5318436" y="2581061"/>
                    <a:ext cx="259274" cy="503999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8" name="Down Arrow 13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17E39E6-C863-9A44-92A5-2835455A5C11}"/>
                      </a:ext>
                    </a:extLst>
                  </p:cNvPr>
                  <p:cNvSpPr>
                    <a:spLocks/>
                  </p:cNvSpPr>
                  <p:nvPr/>
                </p:nvSpPr>
                <p:spPr>
                  <a:xfrm rot="5400000">
                    <a:off x="5812135" y="2726693"/>
                    <a:ext cx="259274" cy="212734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9" name="Down Arrow 13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C548266-E820-F246-B0C2-5A653034FD8B}"/>
                      </a:ext>
                    </a:extLst>
                  </p:cNvPr>
                  <p:cNvSpPr>
                    <a:spLocks/>
                  </p:cNvSpPr>
                  <p:nvPr/>
                </p:nvSpPr>
                <p:spPr>
                  <a:xfrm rot="5400000">
                    <a:off x="6240380" y="2752268"/>
                    <a:ext cx="259274" cy="140734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0" name="Down Arrow 13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03D39C1-A92E-6E46-8A84-27712ECD538E}"/>
                      </a:ext>
                    </a:extLst>
                  </p:cNvPr>
                  <p:cNvSpPr>
                    <a:spLocks/>
                  </p:cNvSpPr>
                  <p:nvPr/>
                </p:nvSpPr>
                <p:spPr>
                  <a:xfrm rot="16200000" flipH="1">
                    <a:off x="3249095" y="2624154"/>
                    <a:ext cx="107998" cy="140734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116" name="Connecteur droit 11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CC220EA-D81F-1345-84F1-6B1D3D82A0B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513366" y="1518611"/>
                  <a:ext cx="16792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7" name="TextBox 11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0437DB4-9C73-1F44-8349-434B0506A81F}"/>
                    </a:ext>
                  </a:extLst>
                </p:cNvPr>
                <p:cNvSpPr txBox="1"/>
                <p:nvPr/>
              </p:nvSpPr>
              <p:spPr>
                <a:xfrm>
                  <a:off x="5305661" y="1524052"/>
                  <a:ext cx="625192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H1</a:t>
                  </a:r>
                </a:p>
              </p:txBody>
            </p:sp>
            <p:cxnSp>
              <p:nvCxnSpPr>
                <p:cNvPr id="114" name="Connecteur droit 113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CC220EA-D81F-1345-84F1-6B1D3D82A0B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252293" y="1518611"/>
                  <a:ext cx="16792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5" name="TextBox 11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0437DB4-9C73-1F44-8349-434B0506A81F}"/>
                    </a:ext>
                  </a:extLst>
                </p:cNvPr>
                <p:cNvSpPr txBox="1"/>
                <p:nvPr/>
              </p:nvSpPr>
              <p:spPr>
                <a:xfrm>
                  <a:off x="6044588" y="1524052"/>
                  <a:ext cx="625192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H3</a:t>
                  </a:r>
                </a:p>
              </p:txBody>
            </p:sp>
            <p:cxnSp>
              <p:nvCxnSpPr>
                <p:cNvPr id="112" name="Connecteur droit 111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CC220EA-D81F-1345-84F1-6B1D3D82A0B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078221" y="1518611"/>
                  <a:ext cx="16792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3" name="TextBox 11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0437DB4-9C73-1F44-8349-434B0506A81F}"/>
                    </a:ext>
                  </a:extLst>
                </p:cNvPr>
                <p:cNvSpPr txBox="1"/>
                <p:nvPr/>
              </p:nvSpPr>
              <p:spPr>
                <a:xfrm>
                  <a:off x="6870516" y="1524052"/>
                  <a:ext cx="625192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H5</a:t>
                  </a:r>
                </a:p>
              </p:txBody>
            </p:sp>
            <p:cxnSp>
              <p:nvCxnSpPr>
                <p:cNvPr id="106" name="Connecteur droit 10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CC220EA-D81F-1345-84F1-6B1D3D82A0B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240444" y="1518611"/>
                  <a:ext cx="16792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7" name="TextBox 11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0437DB4-9C73-1F44-8349-434B0506A81F}"/>
                    </a:ext>
                  </a:extLst>
                </p:cNvPr>
                <p:cNvSpPr txBox="1"/>
                <p:nvPr/>
              </p:nvSpPr>
              <p:spPr>
                <a:xfrm>
                  <a:off x="1899045" y="1524052"/>
                  <a:ext cx="860963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ec3</a:t>
                  </a:r>
                </a:p>
              </p:txBody>
            </p:sp>
            <p:grpSp>
              <p:nvGrpSpPr>
                <p:cNvPr id="100" name="Groupe 24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10C442E-C3E8-7C46-A3B8-C4B5B33F26EA}"/>
                    </a:ext>
                  </a:extLst>
                </p:cNvPr>
                <p:cNvGrpSpPr/>
                <p:nvPr/>
              </p:nvGrpSpPr>
              <p:grpSpPr>
                <a:xfrm>
                  <a:off x="4330572" y="1989117"/>
                  <a:ext cx="860963" cy="261610"/>
                  <a:chOff x="8471607" y="1690954"/>
                  <a:chExt cx="899638" cy="280352"/>
                </a:xfrm>
              </p:grpSpPr>
              <p:cxnSp>
                <p:nvCxnSpPr>
                  <p:cNvPr id="104" name="Connecteur droit 10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CC220EA-D81F-1345-84F1-6B1D3D82A0B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828342" y="1708091"/>
                    <a:ext cx="17547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5" name="TextBox 11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0437DB4-9C73-1F44-8349-434B0506A81F}"/>
                      </a:ext>
                    </a:extLst>
                  </p:cNvPr>
                  <p:cNvSpPr txBox="1"/>
                  <p:nvPr/>
                </p:nvSpPr>
                <p:spPr>
                  <a:xfrm>
                    <a:off x="8471607" y="1690954"/>
                    <a:ext cx="899638" cy="28035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ec4</a:t>
                    </a:r>
                  </a:p>
                </p:txBody>
              </p:sp>
            </p:grpSp>
          </p:grpSp>
          <p:grpSp>
            <p:nvGrpSpPr>
              <p:cNvPr id="2" name="Groupe 1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6147649-255B-1044-8C8D-D4100D3B8829}"/>
                  </a:ext>
                </a:extLst>
              </p:cNvPr>
              <p:cNvGrpSpPr/>
              <p:nvPr/>
            </p:nvGrpSpPr>
            <p:grpSpPr>
              <a:xfrm>
                <a:off x="1658588" y="2583100"/>
                <a:ext cx="7016904" cy="3125623"/>
                <a:chOff x="1658588" y="2583100"/>
                <a:chExt cx="7016904" cy="3125623"/>
              </a:xfrm>
            </p:grpSpPr>
            <p:grpSp>
              <p:nvGrpSpPr>
                <p:cNvPr id="11" name="Groupe 10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4EF0BF3-5B42-654F-8455-92A1F52404DB}"/>
                    </a:ext>
                  </a:extLst>
                </p:cNvPr>
                <p:cNvGrpSpPr/>
                <p:nvPr/>
              </p:nvGrpSpPr>
              <p:grpSpPr>
                <a:xfrm>
                  <a:off x="1658588" y="2583100"/>
                  <a:ext cx="6486894" cy="3125623"/>
                  <a:chOff x="1662918" y="2641020"/>
                  <a:chExt cx="6486894" cy="3125623"/>
                </a:xfrm>
              </p:grpSpPr>
              <p:grpSp>
                <p:nvGrpSpPr>
                  <p:cNvPr id="10" name="Groupe 9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7E7E3CF-6BF1-6C46-9A8D-31EAB38AAB01}"/>
                      </a:ext>
                    </a:extLst>
                  </p:cNvPr>
                  <p:cNvGrpSpPr/>
                  <p:nvPr/>
                </p:nvGrpSpPr>
                <p:grpSpPr>
                  <a:xfrm>
                    <a:off x="2360627" y="4951545"/>
                    <a:ext cx="901339" cy="815098"/>
                    <a:chOff x="2360627" y="4951545"/>
                    <a:chExt cx="901339" cy="815098"/>
                  </a:xfrm>
                </p:grpSpPr>
                <p:sp>
                  <p:nvSpPr>
                    <p:cNvPr id="78" name="Parenthèse ouvrante 77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3A3E82E-4844-EC4B-9BA8-645CCA6865E0}"/>
                        </a:ext>
                      </a:extLst>
                    </p:cNvPr>
                    <p:cNvSpPr/>
                    <p:nvPr/>
                  </p:nvSpPr>
                  <p:spPr>
                    <a:xfrm rot="16200000">
                      <a:off x="2777510" y="5077211"/>
                      <a:ext cx="67572" cy="800442"/>
                    </a:xfrm>
                    <a:prstGeom prst="leftBracket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  <p:sp>
                  <p:nvSpPr>
                    <p:cNvPr id="153" name="ZoneTexte 15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B379FED-2250-5A49-8491-E0888C57F49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73603" y="5489644"/>
                      <a:ext cx="47538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fr-FR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H1</a:t>
                      </a:r>
                    </a:p>
                  </p:txBody>
                </p:sp>
                <p:grpSp>
                  <p:nvGrpSpPr>
                    <p:cNvPr id="9" name="Groupe 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26852A9-F960-794C-B75B-CFD4D27D856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360627" y="4951545"/>
                      <a:ext cx="901339" cy="513209"/>
                      <a:chOff x="2367942" y="4951545"/>
                      <a:chExt cx="901339" cy="513209"/>
                    </a:xfrm>
                  </p:grpSpPr>
                  <p:grpSp>
                    <p:nvGrpSpPr>
                      <p:cNvPr id="6" name="Groupe 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5C8AB82-81A0-DB40-B666-42B725E1C2E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367942" y="4951545"/>
                        <a:ext cx="451149" cy="513209"/>
                        <a:chOff x="2367942" y="4951545"/>
                        <a:chExt cx="451149" cy="513209"/>
                      </a:xfrm>
                    </p:grpSpPr>
                    <p:grpSp>
                      <p:nvGrpSpPr>
                        <p:cNvPr id="4" name="Groupe 3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AA6AB43-4A12-F747-9BA7-0354E0234452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367942" y="4951545"/>
                          <a:ext cx="451149" cy="283349"/>
                          <a:chOff x="2367942" y="4951545"/>
                          <a:chExt cx="451149" cy="283349"/>
                        </a:xfrm>
                      </p:grpSpPr>
                      <p:sp>
                        <p:nvSpPr>
                          <p:cNvPr id="164" name="ZoneTexte 163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47B1F25-D2D1-8C40-BB45-B4E35B190343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367942" y="4951545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165" name="ZoneTexte 164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310CDDA-AF85-4D4F-A44A-D3F7999A947C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557481" y="4957895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166" name="Parenthèse ouvrante 165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28519C1-2B29-2640-9859-73301AD2007E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2559647" y="4993438"/>
                            <a:ext cx="59300" cy="360112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  <p:sp>
                      <p:nvSpPr>
                        <p:cNvPr id="163" name="ZoneTexte 162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DD64D3B-E5FF-9547-9DFC-F91E6FA42C0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385116" y="5203144"/>
                          <a:ext cx="416801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WT</a:t>
                          </a:r>
                        </a:p>
                      </p:txBody>
                    </p:sp>
                  </p:grpSp>
                  <p:grpSp>
                    <p:nvGrpSpPr>
                      <p:cNvPr id="8" name="Groupe 7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D0FCDC3-8ABD-E34F-9A6A-4061EF79889E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723199" y="4957895"/>
                        <a:ext cx="546082" cy="506859"/>
                        <a:chOff x="2723199" y="4957895"/>
                        <a:chExt cx="546082" cy="506859"/>
                      </a:xfrm>
                    </p:grpSpPr>
                    <p:sp>
                      <p:nvSpPr>
                        <p:cNvPr id="157" name="ZoneTexte 156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E5D07DE-750F-1C49-A023-381F4B9464A0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723199" y="5203144"/>
                          <a:ext cx="546082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i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perR</a:t>
                          </a:r>
                          <a:endParaRPr lang="fr-FR" sz="1100" b="1" i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grpSp>
                      <p:nvGrpSpPr>
                        <p:cNvPr id="7" name="Groupe 6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363A2A4-8649-3E4F-BCB8-FCA888E3B2CF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766792" y="4957895"/>
                          <a:ext cx="458897" cy="276999"/>
                          <a:chOff x="2773680" y="4957895"/>
                          <a:chExt cx="458897" cy="276999"/>
                        </a:xfrm>
                      </p:grpSpPr>
                      <p:sp>
                        <p:nvSpPr>
                          <p:cNvPr id="159" name="ZoneTexte 158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EF0ADB6-14A9-504A-8674-7CC0D2D1B891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773680" y="4957895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160" name="ZoneTexte 159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098E67F-8005-0047-96F0-287A9E128219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970967" y="4957895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161" name="Parenthèse ouvrante 160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28519C1-2B29-2640-9859-73301AD2007E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2961127" y="4988436"/>
                            <a:ext cx="59258" cy="370073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</p:grpSp>
                </p:grpSp>
              </p:grpSp>
              <p:pic>
                <p:nvPicPr>
                  <p:cNvPr id="3" name="Image 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6A4FB18-5971-2C48-9A03-FF62CA1D597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/>
                  <a:srcRect l="6015"/>
                  <a:stretch/>
                </p:blipFill>
                <p:spPr>
                  <a:xfrm>
                    <a:off x="2022438" y="2641020"/>
                    <a:ext cx="6127374" cy="2434739"/>
                  </a:xfrm>
                  <a:prstGeom prst="rect">
                    <a:avLst/>
                  </a:prstGeom>
                </p:spPr>
              </p:pic>
              <p:grpSp>
                <p:nvGrpSpPr>
                  <p:cNvPr id="296" name="Groupe 29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CF535B1-BC62-AB42-9739-B7CCD8AD4002}"/>
                      </a:ext>
                    </a:extLst>
                  </p:cNvPr>
                  <p:cNvGrpSpPr/>
                  <p:nvPr/>
                </p:nvGrpSpPr>
                <p:grpSpPr>
                  <a:xfrm>
                    <a:off x="3326749" y="4951545"/>
                    <a:ext cx="901339" cy="815098"/>
                    <a:chOff x="2360627" y="4951545"/>
                    <a:chExt cx="901339" cy="815098"/>
                  </a:xfrm>
                </p:grpSpPr>
                <p:sp>
                  <p:nvSpPr>
                    <p:cNvPr id="297" name="Parenthèse ouvrante 296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DA575BD-6336-754C-AE11-224D84A05A38}"/>
                        </a:ext>
                      </a:extLst>
                    </p:cNvPr>
                    <p:cNvSpPr/>
                    <p:nvPr/>
                  </p:nvSpPr>
                  <p:spPr>
                    <a:xfrm rot="16200000">
                      <a:off x="2777510" y="5077211"/>
                      <a:ext cx="67572" cy="800442"/>
                    </a:xfrm>
                    <a:prstGeom prst="leftBracket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  <p:sp>
                  <p:nvSpPr>
                    <p:cNvPr id="298" name="ZoneTexte 297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1C5B5EF-07E0-F14F-A92C-AB9A582F37A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73603" y="5489644"/>
                      <a:ext cx="47481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fr-FR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H3</a:t>
                      </a:r>
                    </a:p>
                  </p:txBody>
                </p:sp>
                <p:grpSp>
                  <p:nvGrpSpPr>
                    <p:cNvPr id="299" name="Groupe 29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B3D38F1-B1A8-CA44-A629-D955DF78714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360627" y="4951545"/>
                      <a:ext cx="901339" cy="513209"/>
                      <a:chOff x="2367942" y="4951545"/>
                      <a:chExt cx="901339" cy="513209"/>
                    </a:xfrm>
                  </p:grpSpPr>
                  <p:grpSp>
                    <p:nvGrpSpPr>
                      <p:cNvPr id="300" name="Groupe 299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9587B65-C7B6-DB4D-AE31-9B0D222AC34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367942" y="4951545"/>
                        <a:ext cx="451149" cy="513209"/>
                        <a:chOff x="2367942" y="4951545"/>
                        <a:chExt cx="451149" cy="513209"/>
                      </a:xfrm>
                    </p:grpSpPr>
                    <p:grpSp>
                      <p:nvGrpSpPr>
                        <p:cNvPr id="307" name="Groupe 306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9CC1209-39F8-064D-A073-E6C4EF407ED7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367942" y="4951545"/>
                          <a:ext cx="451149" cy="283349"/>
                          <a:chOff x="2367942" y="4951545"/>
                          <a:chExt cx="451149" cy="283349"/>
                        </a:xfrm>
                      </p:grpSpPr>
                      <p:sp>
                        <p:nvSpPr>
                          <p:cNvPr id="309" name="ZoneTexte 308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E097318-8303-B847-B8ED-DF6F2BDAD1DF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367942" y="4951545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310" name="ZoneTexte 309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3F7B5B9-4E87-8448-893F-D7884A06A047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557481" y="4957895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311" name="Parenthèse ouvrante 310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F26F659-59FC-3246-B0C3-795125010F45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2559647" y="4993438"/>
                            <a:ext cx="59300" cy="360112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  <p:sp>
                      <p:nvSpPr>
                        <p:cNvPr id="308" name="ZoneTexte 307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D047AAD-D258-7E49-ABB8-8EC2DD5BD8E6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385116" y="5203144"/>
                          <a:ext cx="416801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WT</a:t>
                          </a:r>
                        </a:p>
                      </p:txBody>
                    </p:sp>
                  </p:grpSp>
                  <p:grpSp>
                    <p:nvGrpSpPr>
                      <p:cNvPr id="301" name="Groupe 300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F860734-5299-024F-A7E1-2317FB5BD71A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723199" y="4957895"/>
                        <a:ext cx="546082" cy="506859"/>
                        <a:chOff x="2723199" y="4957895"/>
                        <a:chExt cx="546082" cy="506859"/>
                      </a:xfrm>
                    </p:grpSpPr>
                    <p:sp>
                      <p:nvSpPr>
                        <p:cNvPr id="302" name="ZoneTexte 301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7906CB7-9FF1-1E49-AD44-ED07B1C5BCC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723199" y="5203144"/>
                          <a:ext cx="546082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i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perR</a:t>
                          </a:r>
                          <a:endParaRPr lang="fr-FR" sz="1100" b="1" i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grpSp>
                      <p:nvGrpSpPr>
                        <p:cNvPr id="303" name="Groupe 302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BB6D47F-C43C-5949-94D8-B429752047CB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766792" y="4957895"/>
                          <a:ext cx="458897" cy="276999"/>
                          <a:chOff x="2773680" y="4957895"/>
                          <a:chExt cx="458897" cy="276999"/>
                        </a:xfrm>
                      </p:grpSpPr>
                      <p:sp>
                        <p:nvSpPr>
                          <p:cNvPr id="304" name="ZoneTexte 303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8D85AF7-FA3F-DC44-BEC8-5BBF4DF7298C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773680" y="4957895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305" name="ZoneTexte 304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9409099-A22A-0C43-9E79-30A6C91020E8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970967" y="4957895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306" name="Parenthèse ouvrante 305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74E6390-0FA3-5D46-90D3-30A0FE111EE8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2961127" y="4988436"/>
                            <a:ext cx="59258" cy="370073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</p:grpSp>
                </p:grpSp>
              </p:grpSp>
              <p:grpSp>
                <p:nvGrpSpPr>
                  <p:cNvPr id="312" name="Groupe 31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4390EEA-0FD5-BA42-A726-30843A4BF749}"/>
                      </a:ext>
                    </a:extLst>
                  </p:cNvPr>
                  <p:cNvGrpSpPr/>
                  <p:nvPr/>
                </p:nvGrpSpPr>
                <p:grpSpPr>
                  <a:xfrm>
                    <a:off x="5249981" y="4951545"/>
                    <a:ext cx="901339" cy="815098"/>
                    <a:chOff x="2360627" y="4951545"/>
                    <a:chExt cx="901339" cy="815098"/>
                  </a:xfrm>
                </p:grpSpPr>
                <p:sp>
                  <p:nvSpPr>
                    <p:cNvPr id="313" name="Parenthèse ouvrante 31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31AD44C-05E8-B942-B09A-61B7B3CD3B9B}"/>
                        </a:ext>
                      </a:extLst>
                    </p:cNvPr>
                    <p:cNvSpPr/>
                    <p:nvPr/>
                  </p:nvSpPr>
                  <p:spPr>
                    <a:xfrm rot="16200000">
                      <a:off x="2777510" y="5077211"/>
                      <a:ext cx="67572" cy="800442"/>
                    </a:xfrm>
                    <a:prstGeom prst="leftBracket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  <p:sp>
                  <p:nvSpPr>
                    <p:cNvPr id="314" name="ZoneTexte 31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7C41158-26CA-5243-9603-C8B0FEA73C3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22398" y="5489644"/>
                      <a:ext cx="534121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fr-FR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c3</a:t>
                      </a:r>
                    </a:p>
                  </p:txBody>
                </p:sp>
                <p:grpSp>
                  <p:nvGrpSpPr>
                    <p:cNvPr id="315" name="Groupe 314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5FBACC6-8F44-EE4B-9564-0D566A7D88C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360627" y="4951545"/>
                      <a:ext cx="901339" cy="513209"/>
                      <a:chOff x="2367942" y="4951545"/>
                      <a:chExt cx="901339" cy="513209"/>
                    </a:xfrm>
                  </p:grpSpPr>
                  <p:grpSp>
                    <p:nvGrpSpPr>
                      <p:cNvPr id="316" name="Groupe 31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88CE7F7-95ED-2743-86DF-67335B2BEB6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367942" y="4951545"/>
                        <a:ext cx="451149" cy="513209"/>
                        <a:chOff x="2367942" y="4951545"/>
                        <a:chExt cx="451149" cy="513209"/>
                      </a:xfrm>
                    </p:grpSpPr>
                    <p:grpSp>
                      <p:nvGrpSpPr>
                        <p:cNvPr id="323" name="Groupe 322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8172B21-99DD-524B-A66C-ADD2BE901A72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367942" y="4951545"/>
                          <a:ext cx="451149" cy="283349"/>
                          <a:chOff x="2367942" y="4951545"/>
                          <a:chExt cx="451149" cy="283349"/>
                        </a:xfrm>
                      </p:grpSpPr>
                      <p:sp>
                        <p:nvSpPr>
                          <p:cNvPr id="325" name="ZoneTexte 324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D84F7A2-3677-A64F-B72D-87C3E9E5F4CD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367942" y="4951545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326" name="ZoneTexte 325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782725A-AEBD-4F42-BE39-E38E72B80F88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557481" y="4957895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327" name="Parenthèse ouvrante 326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468583A-4E6B-A242-BCEE-EFB3A2BAC535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2559647" y="4993438"/>
                            <a:ext cx="59300" cy="360112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  <p:sp>
                      <p:nvSpPr>
                        <p:cNvPr id="324" name="ZoneTexte 323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8859E30-7932-1C41-8CA7-2F6B89F3C2C9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385116" y="5203144"/>
                          <a:ext cx="416801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WT</a:t>
                          </a:r>
                        </a:p>
                      </p:txBody>
                    </p:sp>
                  </p:grpSp>
                  <p:grpSp>
                    <p:nvGrpSpPr>
                      <p:cNvPr id="317" name="Groupe 316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DB8A985-717B-D446-AA7E-1FCD438FB96B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723199" y="4957895"/>
                        <a:ext cx="546082" cy="506859"/>
                        <a:chOff x="2723199" y="4957895"/>
                        <a:chExt cx="546082" cy="506859"/>
                      </a:xfrm>
                    </p:grpSpPr>
                    <p:sp>
                      <p:nvSpPr>
                        <p:cNvPr id="318" name="ZoneTexte 317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8521EED-8F45-9D4A-A5E0-2E0230AEF638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723199" y="5203144"/>
                          <a:ext cx="546082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i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perR</a:t>
                          </a:r>
                          <a:endParaRPr lang="fr-FR" sz="1100" b="1" i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grpSp>
                      <p:nvGrpSpPr>
                        <p:cNvPr id="319" name="Groupe 318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B3BDB59-63B5-8A4D-8992-ECAF67A239CF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766792" y="4957895"/>
                          <a:ext cx="458897" cy="276999"/>
                          <a:chOff x="2773680" y="4957895"/>
                          <a:chExt cx="458897" cy="276999"/>
                        </a:xfrm>
                      </p:grpSpPr>
                      <p:sp>
                        <p:nvSpPr>
                          <p:cNvPr id="320" name="ZoneTexte 319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F39A0B2-6E82-F641-AF32-69C611CD8CB2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773680" y="4957895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321" name="ZoneTexte 320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730F725-8B29-FF48-A698-8163B8564999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970967" y="4957895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322" name="Parenthèse ouvrante 321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97AF074-5E0A-CD4F-A9E3-1EE451CDD8C8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2961127" y="4988436"/>
                            <a:ext cx="59258" cy="370073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</p:grpSp>
                </p:grpSp>
              </p:grpSp>
              <p:grpSp>
                <p:nvGrpSpPr>
                  <p:cNvPr id="344" name="Groupe 34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17AE34A-6438-A949-8A56-455C5D34110D}"/>
                      </a:ext>
                    </a:extLst>
                  </p:cNvPr>
                  <p:cNvGrpSpPr/>
                  <p:nvPr/>
                </p:nvGrpSpPr>
                <p:grpSpPr>
                  <a:xfrm>
                    <a:off x="6219346" y="4951545"/>
                    <a:ext cx="901339" cy="815098"/>
                    <a:chOff x="2360627" y="4951545"/>
                    <a:chExt cx="901339" cy="815098"/>
                  </a:xfrm>
                </p:grpSpPr>
                <p:sp>
                  <p:nvSpPr>
                    <p:cNvPr id="345" name="Parenthèse ouvrante 344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6C7B78F-4933-3049-AAFD-5E4F9B9155B1}"/>
                        </a:ext>
                      </a:extLst>
                    </p:cNvPr>
                    <p:cNvSpPr/>
                    <p:nvPr/>
                  </p:nvSpPr>
                  <p:spPr>
                    <a:xfrm rot="16200000">
                      <a:off x="2777510" y="5077211"/>
                      <a:ext cx="67572" cy="800442"/>
                    </a:xfrm>
                    <a:prstGeom prst="leftBracket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  <p:sp>
                  <p:nvSpPr>
                    <p:cNvPr id="346" name="ZoneTexte 34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5185C5F-C34D-0045-920B-8C99C526C08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22398" y="5489644"/>
                      <a:ext cx="534121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fr-FR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c4</a:t>
                      </a:r>
                    </a:p>
                  </p:txBody>
                </p:sp>
                <p:grpSp>
                  <p:nvGrpSpPr>
                    <p:cNvPr id="347" name="Groupe 346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458C63C-FE61-764A-97A1-F71CD6C8DE3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360627" y="4951545"/>
                      <a:ext cx="901339" cy="513209"/>
                      <a:chOff x="2367942" y="4951545"/>
                      <a:chExt cx="901339" cy="513209"/>
                    </a:xfrm>
                  </p:grpSpPr>
                  <p:grpSp>
                    <p:nvGrpSpPr>
                      <p:cNvPr id="348" name="Groupe 347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E6544D3-8E82-2744-9296-9EC46E1629F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367942" y="4951545"/>
                        <a:ext cx="443834" cy="513209"/>
                        <a:chOff x="2367942" y="4951545"/>
                        <a:chExt cx="443834" cy="513209"/>
                      </a:xfrm>
                    </p:grpSpPr>
                    <p:grpSp>
                      <p:nvGrpSpPr>
                        <p:cNvPr id="355" name="Groupe 354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C175752-164C-A04B-B41F-3B477B2754E9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367942" y="4951545"/>
                          <a:ext cx="443834" cy="283349"/>
                          <a:chOff x="2367942" y="4951545"/>
                          <a:chExt cx="443834" cy="283349"/>
                        </a:xfrm>
                      </p:grpSpPr>
                      <p:sp>
                        <p:nvSpPr>
                          <p:cNvPr id="357" name="ZoneTexte 356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E50F09B-D268-5D41-8AF6-383F753670F3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367942" y="4951545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358" name="ZoneTexte 357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5314D8A-505D-F547-998A-3BC3E9AFAB98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550166" y="4957895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359" name="Parenthèse ouvrante 358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0DE196B-A0DD-FC4C-8369-9518ADCFD10E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2559647" y="4993438"/>
                            <a:ext cx="59300" cy="360112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  <p:sp>
                      <p:nvSpPr>
                        <p:cNvPr id="356" name="ZoneTexte 355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B5C90B7-4F3B-C042-8863-9794836ECD56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385116" y="5203144"/>
                          <a:ext cx="416801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WT</a:t>
                          </a:r>
                        </a:p>
                      </p:txBody>
                    </p:sp>
                  </p:grpSp>
                  <p:grpSp>
                    <p:nvGrpSpPr>
                      <p:cNvPr id="349" name="Groupe 348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17598CE-18C5-BC4C-8A76-EC9FEC0F657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723199" y="4957895"/>
                        <a:ext cx="546082" cy="506859"/>
                        <a:chOff x="2723199" y="4957895"/>
                        <a:chExt cx="546082" cy="506859"/>
                      </a:xfrm>
                    </p:grpSpPr>
                    <p:sp>
                      <p:nvSpPr>
                        <p:cNvPr id="350" name="ZoneTexte 349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7E909A9-2E5A-2147-AAB8-8BD6FF4DEED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723199" y="5203144"/>
                          <a:ext cx="546082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i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perR</a:t>
                          </a:r>
                          <a:endParaRPr lang="fr-FR" sz="1100" b="1" i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grpSp>
                      <p:nvGrpSpPr>
                        <p:cNvPr id="351" name="Groupe 350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215E53A-6D16-6246-BCBF-625A7347C066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766792" y="4957895"/>
                          <a:ext cx="458897" cy="276999"/>
                          <a:chOff x="2773680" y="4957895"/>
                          <a:chExt cx="458897" cy="276999"/>
                        </a:xfrm>
                      </p:grpSpPr>
                      <p:sp>
                        <p:nvSpPr>
                          <p:cNvPr id="352" name="ZoneTexte 351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7D082DA-F1EA-514B-A52E-C1CA717A41D0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773680" y="4957895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353" name="ZoneTexte 352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01D95B8-6ECD-4042-A50D-36EE1C2BE2CD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970967" y="4957895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354" name="Parenthèse ouvrante 353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37C285B-D43E-C742-AF54-DE955B2EEF4D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2961127" y="4988436"/>
                            <a:ext cx="59258" cy="370073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</p:grpSp>
                </p:grpSp>
              </p:grpSp>
              <p:grpSp>
                <p:nvGrpSpPr>
                  <p:cNvPr id="360" name="Groupe 359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DE29E25-638E-B44A-A6AB-586A306F132C}"/>
                      </a:ext>
                    </a:extLst>
                  </p:cNvPr>
                  <p:cNvGrpSpPr/>
                  <p:nvPr/>
                </p:nvGrpSpPr>
                <p:grpSpPr>
                  <a:xfrm>
                    <a:off x="7167926" y="4951545"/>
                    <a:ext cx="901339" cy="815098"/>
                    <a:chOff x="2360627" y="4951545"/>
                    <a:chExt cx="901339" cy="815098"/>
                  </a:xfrm>
                </p:grpSpPr>
                <p:sp>
                  <p:nvSpPr>
                    <p:cNvPr id="361" name="Parenthèse ouvrante 36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E85C9D2-2FDC-7F46-B909-E948F3B50FCB}"/>
                        </a:ext>
                      </a:extLst>
                    </p:cNvPr>
                    <p:cNvSpPr/>
                    <p:nvPr/>
                  </p:nvSpPr>
                  <p:spPr>
                    <a:xfrm rot="16200000">
                      <a:off x="2777510" y="5077211"/>
                      <a:ext cx="67572" cy="800442"/>
                    </a:xfrm>
                    <a:prstGeom prst="leftBracket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  <p:sp>
                  <p:nvSpPr>
                    <p:cNvPr id="362" name="ZoneTexte 361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41D8DE6-9B83-C347-821C-323FBD25CF5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22398" y="5489644"/>
                      <a:ext cx="534121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fr-FR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c5</a:t>
                      </a:r>
                    </a:p>
                  </p:txBody>
                </p:sp>
                <p:grpSp>
                  <p:nvGrpSpPr>
                    <p:cNvPr id="363" name="Groupe 36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1F2D925-DD58-D545-9152-D1703DDD23A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360627" y="4951545"/>
                      <a:ext cx="901339" cy="513209"/>
                      <a:chOff x="2367942" y="4951545"/>
                      <a:chExt cx="901339" cy="513209"/>
                    </a:xfrm>
                  </p:grpSpPr>
                  <p:grpSp>
                    <p:nvGrpSpPr>
                      <p:cNvPr id="364" name="Groupe 36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E76B978-9E8C-364F-95AA-42B3AD57170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367942" y="4951545"/>
                        <a:ext cx="451149" cy="513209"/>
                        <a:chOff x="2367942" y="4951545"/>
                        <a:chExt cx="451149" cy="513209"/>
                      </a:xfrm>
                    </p:grpSpPr>
                    <p:grpSp>
                      <p:nvGrpSpPr>
                        <p:cNvPr id="371" name="Groupe 370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F0D8B54-257A-CF40-ACBC-5A8B36275FE9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367942" y="4951545"/>
                          <a:ext cx="451149" cy="283349"/>
                          <a:chOff x="2367942" y="4951545"/>
                          <a:chExt cx="451149" cy="283349"/>
                        </a:xfrm>
                      </p:grpSpPr>
                      <p:sp>
                        <p:nvSpPr>
                          <p:cNvPr id="373" name="ZoneTexte 372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29DE3E7-83A1-F948-91C7-AE9541B370EC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367942" y="4951545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374" name="ZoneTexte 373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CB67E98-84DF-0048-A1FF-151AAF112D8A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557481" y="4957895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375" name="Parenthèse ouvrante 374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9F85559-C58F-9440-A95E-BD74A5BD0654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2559647" y="4993438"/>
                            <a:ext cx="59300" cy="360112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  <p:sp>
                      <p:nvSpPr>
                        <p:cNvPr id="372" name="ZoneTexte 371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E87E321-3D34-C845-82B5-AB97BD51C331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385116" y="5203144"/>
                          <a:ext cx="416801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WT</a:t>
                          </a:r>
                        </a:p>
                      </p:txBody>
                    </p:sp>
                  </p:grpSp>
                  <p:grpSp>
                    <p:nvGrpSpPr>
                      <p:cNvPr id="365" name="Groupe 364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BC17766-DC8B-FA4D-A387-5BECDAF5D331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723199" y="4957895"/>
                        <a:ext cx="546082" cy="506859"/>
                        <a:chOff x="2723199" y="4957895"/>
                        <a:chExt cx="546082" cy="506859"/>
                      </a:xfrm>
                    </p:grpSpPr>
                    <p:sp>
                      <p:nvSpPr>
                        <p:cNvPr id="366" name="ZoneTexte 365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4F74984-36E4-894B-A96B-87A7CF18257F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723199" y="5203144"/>
                          <a:ext cx="546082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i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perR</a:t>
                          </a:r>
                          <a:endParaRPr lang="fr-FR" sz="1100" b="1" i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grpSp>
                      <p:nvGrpSpPr>
                        <p:cNvPr id="367" name="Groupe 366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69C1AB2-5408-B04A-BC2C-A1F3BA65781C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766792" y="4957895"/>
                          <a:ext cx="458897" cy="276999"/>
                          <a:chOff x="2773680" y="4957895"/>
                          <a:chExt cx="458897" cy="276999"/>
                        </a:xfrm>
                      </p:grpSpPr>
                      <p:sp>
                        <p:nvSpPr>
                          <p:cNvPr id="368" name="ZoneTexte 367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B54AA4B-D0E4-BE4B-96B1-B9074A80DCF6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773680" y="4957895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369" name="ZoneTexte 368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3AAC480-CF53-ED4C-BF84-36CE887AA895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970967" y="4957895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370" name="Parenthèse ouvrante 369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AF370E6-8EB4-534B-A82A-3FC00E47DBFF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2961127" y="4988436"/>
                            <a:ext cx="59258" cy="370073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</p:grpSp>
                </p:grpSp>
              </p:grpSp>
              <p:grpSp>
                <p:nvGrpSpPr>
                  <p:cNvPr id="376" name="Groupe 37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F0AE49A-BCB8-F041-B7DA-C92679CFBDDB}"/>
                      </a:ext>
                    </a:extLst>
                  </p:cNvPr>
                  <p:cNvGrpSpPr/>
                  <p:nvPr/>
                </p:nvGrpSpPr>
                <p:grpSpPr>
                  <a:xfrm>
                    <a:off x="4283818" y="4951545"/>
                    <a:ext cx="901339" cy="815098"/>
                    <a:chOff x="2360627" y="4951545"/>
                    <a:chExt cx="901339" cy="815098"/>
                  </a:xfrm>
                </p:grpSpPr>
                <p:sp>
                  <p:nvSpPr>
                    <p:cNvPr id="377" name="Parenthèse ouvrante 376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21E6E48-3773-8044-B0E5-4AB7BE83DFA0}"/>
                        </a:ext>
                      </a:extLst>
                    </p:cNvPr>
                    <p:cNvSpPr/>
                    <p:nvPr/>
                  </p:nvSpPr>
                  <p:spPr>
                    <a:xfrm rot="16200000">
                      <a:off x="2777510" y="5077211"/>
                      <a:ext cx="67572" cy="800442"/>
                    </a:xfrm>
                    <a:prstGeom prst="leftBracket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  <p:sp>
                  <p:nvSpPr>
                    <p:cNvPr id="378" name="ZoneTexte 377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FECBB2F-4041-2A41-BF0B-BB0064062CA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51658" y="5489644"/>
                      <a:ext cx="47481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fr-FR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H5</a:t>
                      </a:r>
                    </a:p>
                  </p:txBody>
                </p:sp>
                <p:grpSp>
                  <p:nvGrpSpPr>
                    <p:cNvPr id="379" name="Groupe 37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AF3703A-C249-054B-B6A4-238CCA7E1F3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360627" y="4951545"/>
                      <a:ext cx="901339" cy="513209"/>
                      <a:chOff x="2367942" y="4951545"/>
                      <a:chExt cx="901339" cy="513209"/>
                    </a:xfrm>
                  </p:grpSpPr>
                  <p:grpSp>
                    <p:nvGrpSpPr>
                      <p:cNvPr id="380" name="Groupe 379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C718EB2-F73E-E74D-8F0E-F845F2117FF2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367942" y="4951545"/>
                        <a:ext cx="451149" cy="513209"/>
                        <a:chOff x="2367942" y="4951545"/>
                        <a:chExt cx="451149" cy="513209"/>
                      </a:xfrm>
                    </p:grpSpPr>
                    <p:grpSp>
                      <p:nvGrpSpPr>
                        <p:cNvPr id="387" name="Groupe 386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C2A92B1-E960-F842-ACE7-0CAC205DDC40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367942" y="4951545"/>
                          <a:ext cx="451149" cy="283349"/>
                          <a:chOff x="2367942" y="4951545"/>
                          <a:chExt cx="451149" cy="283349"/>
                        </a:xfrm>
                      </p:grpSpPr>
                      <p:sp>
                        <p:nvSpPr>
                          <p:cNvPr id="389" name="ZoneTexte 388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B3C22BB-4B79-F94C-9D6F-3554053DBDA7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367942" y="4951545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390" name="ZoneTexte 389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570F201-3BFA-FA43-8692-40D59CB11C94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557481" y="4957895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391" name="Parenthèse ouvrante 390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AAE2C72-DF92-0545-A165-83EC7B6ADD4A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2559647" y="4993438"/>
                            <a:ext cx="59300" cy="360112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  <p:sp>
                      <p:nvSpPr>
                        <p:cNvPr id="388" name="ZoneTexte 387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3448851-2BC5-AF49-A9C6-4326F46A8987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385116" y="5203144"/>
                          <a:ext cx="416801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WT</a:t>
                          </a:r>
                        </a:p>
                      </p:txBody>
                    </p:sp>
                  </p:grpSp>
                  <p:grpSp>
                    <p:nvGrpSpPr>
                      <p:cNvPr id="381" name="Groupe 380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2FCF8C5-C016-7649-922F-37D3ED7F9EDB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723199" y="4957895"/>
                        <a:ext cx="546082" cy="506859"/>
                        <a:chOff x="2723199" y="4957895"/>
                        <a:chExt cx="546082" cy="506859"/>
                      </a:xfrm>
                    </p:grpSpPr>
                    <p:sp>
                      <p:nvSpPr>
                        <p:cNvPr id="382" name="ZoneTexte 381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3C44C33-D2C7-4A48-8918-B5A5EE98210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723199" y="5203144"/>
                          <a:ext cx="546082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i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perR</a:t>
                          </a:r>
                          <a:endParaRPr lang="fr-FR" sz="1100" b="1" i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grpSp>
                      <p:nvGrpSpPr>
                        <p:cNvPr id="383" name="Groupe 382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EE95ACA-FC2D-0F42-8850-26408AFE855F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766792" y="4957895"/>
                          <a:ext cx="458897" cy="276999"/>
                          <a:chOff x="2773680" y="4957895"/>
                          <a:chExt cx="458897" cy="276999"/>
                        </a:xfrm>
                      </p:grpSpPr>
                      <p:sp>
                        <p:nvSpPr>
                          <p:cNvPr id="384" name="ZoneTexte 383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69F0856-2E82-CE4E-B252-896D34EE3B42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773680" y="4957895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385" name="ZoneTexte 384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8C513CD-25E1-FE4C-AE96-7C50A76D6E54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970967" y="4957895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386" name="Parenthèse ouvrante 385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225AFBB-1A26-D04C-9128-0477B1AF7127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2961127" y="4988436"/>
                            <a:ext cx="59258" cy="370073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</p:grpSp>
                </p:grpSp>
              </p:grpSp>
              <p:sp>
                <p:nvSpPr>
                  <p:cNvPr id="392" name="ZoneTexte 39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65FD862-7B2C-3347-B7A1-A56B9B65F47A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109562" y="3719890"/>
                    <a:ext cx="138371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12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old</a:t>
                    </a:r>
                    <a:r>
                      <a:rPr lang="fr-FR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fr-FR" sz="12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nrichment</a:t>
                    </a:r>
                    <a:endParaRPr lang="fr-FR" sz="1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73" name="ZoneTexte 172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E8312AE-2D0B-4847-AE7F-4DF6760F1DA7}"/>
                    </a:ext>
                  </a:extLst>
                </p:cNvPr>
                <p:cNvSpPr txBox="1"/>
                <p:nvPr/>
              </p:nvSpPr>
              <p:spPr>
                <a:xfrm>
                  <a:off x="7957026" y="4912534"/>
                  <a:ext cx="71846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antibody</a:t>
                  </a:r>
                  <a:endParaRPr lang="fr-FR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a="http://schemas.openxmlformats.org/drawingml/2006/main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8</TotalTime>
  <Words>96</Words>
  <Application>Microsoft Macintosh PowerPoint</Application>
  <PresentationFormat>Format A4 (210 x 297 mm)</PresentationFormat>
  <Paragraphs>92</Paragraphs>
  <Slides>1</Slides>
  <Notes>1</Notes>
  <HiddenSlides>0</HiddenSlides>
  <MMClips>0</MMClips>
  <ScaleCrop>false</ScaleCrop>
  <HeadingPairs>
    <vt:vector size="4" baseType="variant">
      <vt:variant>
        <vt:lpstr>Modèle de conception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nadia benaroudj</dc:creator>
  <cp:lastModifiedBy>nadia benaroudj</cp:lastModifiedBy>
  <cp:revision>15</cp:revision>
  <cp:lastPrinted>2020-03-17T22:46:04Z</cp:lastPrinted>
  <dcterms:created xsi:type="dcterms:W3CDTF">2020-04-03T13:32:57Z</dcterms:created>
  <dcterms:modified xsi:type="dcterms:W3CDTF">2020-04-03T13:34:07Z</dcterms:modified>
</cp:coreProperties>
</file>